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6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81"/>
    <p:restoredTop sz="94524"/>
  </p:normalViewPr>
  <p:slideViewPr>
    <p:cSldViewPr snapToGrid="0">
      <p:cViewPr varScale="1">
        <p:scale>
          <a:sx n="140" d="100"/>
          <a:sy n="140" d="100"/>
        </p:scale>
        <p:origin x="42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FD30CD4-41C9-5542-D7EF-D999D95661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0324733"/>
              </p:ext>
            </p:extLst>
          </p:nvPr>
        </p:nvGraphicFramePr>
        <p:xfrm>
          <a:off x="471487" y="1224740"/>
          <a:ext cx="4333875" cy="3478854"/>
        </p:xfrm>
        <a:graphic>
          <a:graphicData uri="http://schemas.openxmlformats.org/drawingml/2006/table">
            <a:tbl>
              <a:tblPr/>
              <a:tblGrid>
                <a:gridCol w="990600">
                  <a:extLst>
                    <a:ext uri="{9D8B030D-6E8A-4147-A177-3AD203B41FA5}">
                      <a16:colId xmlns:a16="http://schemas.microsoft.com/office/drawing/2014/main" val="3010813318"/>
                    </a:ext>
                  </a:extLst>
                </a:gridCol>
                <a:gridCol w="885825">
                  <a:extLst>
                    <a:ext uri="{9D8B030D-6E8A-4147-A177-3AD203B41FA5}">
                      <a16:colId xmlns:a16="http://schemas.microsoft.com/office/drawing/2014/main" val="206218394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032362501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167391895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val="39426012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200"/>
                        </a:lnSpc>
                        <a:spcAft>
                          <a:spcPts val="800"/>
                        </a:spcAft>
                      </a:pPr>
                      <a:r>
                        <a:rPr lang="en-US" sz="1000" b="0" i="0">
                          <a:effectLst/>
                          <a:latin typeface="Helvetica Neue" panose="02000503000000020004" pitchFamily="2" charset="0"/>
                        </a:rPr>
                        <a:t> 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2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5</a:t>
                      </a:r>
                      <a:r>
                        <a:rPr lang="en-US" sz="800" b="1" i="0" baseline="3000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h</a:t>
                      </a: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 percentile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2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Median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2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5th percentile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2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00</a:t>
                      </a:r>
                      <a:r>
                        <a:rPr lang="en-US" sz="800" b="1" i="0" baseline="3000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h</a:t>
                      </a: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 percentile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39410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NSCLC (n=185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12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8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.7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90.0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60944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SCLC (n=53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0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1.05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7.43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90.0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9619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RCC (n=50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0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3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7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9.6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259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MM (n=46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13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88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4.7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4.4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6399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BlC (n=42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4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.0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2.1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90.0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97167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HNSCC (n=41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25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0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.1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86.4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10182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HCC (n=24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28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0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.9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50.3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34067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GE (n=23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12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6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.75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2.03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93043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EC (n=18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7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6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.7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6.0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635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CRC (n=17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1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9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2.72 </a:t>
                      </a:r>
                      <a:endParaRPr lang="en-US" b="0" i="0" dirty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7.89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54624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PC (n=16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.55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1.7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3.71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90.0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31433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BrC (n=14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.26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6.85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2.8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57.64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36353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MCC (n=3)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03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0.9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.70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>
                        <a:lnSpc>
                          <a:spcPts val="1125"/>
                        </a:lnSpc>
                      </a:pPr>
                      <a:r>
                        <a:rPr lang="en-US" sz="900" b="0" i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.70 </a:t>
                      </a:r>
                      <a:endParaRPr lang="en-US" b="0" i="0" dirty="0">
                        <a:effectLst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3623105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C0D9B14A-9957-2CBD-2226-A054F79CD6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487" y="4800971"/>
            <a:ext cx="4459328" cy="30777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Supplementary Table S4. Quartiles of baseline TF across cancer type among those with TF detected (n=532) 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48CE184C-068B-DCD9-3C7C-1848BA5807BE}"/>
              </a:ext>
            </a:extLst>
          </p:cNvPr>
          <p:cNvSpPr txBox="1">
            <a:spLocks/>
          </p:cNvSpPr>
          <p:nvPr/>
        </p:nvSpPr>
        <p:spPr>
          <a:xfrm>
            <a:off x="471488" y="486836"/>
            <a:ext cx="5915025" cy="4212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 sz="1000" b="1" dirty="0">
              <a:latin typeface="Helvetica Neue" panose="02000503000000020004" pitchFamily="2" charset="0"/>
              <a:ea typeface="Helvetica Neue" panose="02000503000000020004" pitchFamily="2" charset="0"/>
              <a:cs typeface="Helvetica Neue" panose="02000503000000020004" pitchFamily="2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980EE63-F4F8-19D3-E375-E5D39B76EFA1}"/>
              </a:ext>
            </a:extLst>
          </p:cNvPr>
          <p:cNvSpPr txBox="1"/>
          <p:nvPr/>
        </p:nvSpPr>
        <p:spPr>
          <a:xfrm>
            <a:off x="288036" y="538717"/>
            <a:ext cx="3216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 Supplementary </a:t>
            </a: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Tabl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6910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0</TotalTime>
  <Words>163</Words>
  <Application>Microsoft Macintosh PowerPoint</Application>
  <PresentationFormat>Letter Paper (8.5x11 in)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5</cp:revision>
  <dcterms:created xsi:type="dcterms:W3CDTF">2024-12-13T18:22:33Z</dcterms:created>
  <dcterms:modified xsi:type="dcterms:W3CDTF">2025-07-09T17:07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